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B2C321F-4871-4F0A-8339-9258FE0DEA7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CE83DAD-FD57-4A6F-B395-82CA674E627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D127566-ADCE-476B-B2B8-1E94EC36C82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AEEB38B-CEB2-45BC-A352-16064FA234A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8CBDF17-DE0F-4ACF-8A0E-4AB26FD3F81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319337E-D2B3-4DCB-8194-A119D90E1A8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801D87F-64F8-497D-8E50-44CA265B811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23F60CD-7689-4025-83BB-9CC3EFE5A20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D0E0BBA-E365-4F8E-AD34-47C485EEC81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C3AF635-DB42-44C0-BD9F-DEA80859C63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8CEE481-66E8-426A-9837-21FEA63CC2E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E8785DB-853D-4DA4-8F87-21059FC8330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EF8579E-9E79-4F3B-9626-4748035570AE}" type="slidenum">
              <a:rPr b="0" lang="it-IT"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 descr="C:\Users\c10218\Downloads\72691_Ammassari-Teule_Figure_5.TIF"/>
          <p:cNvPicPr/>
          <p:nvPr/>
        </p:nvPicPr>
        <p:blipFill>
          <a:blip r:embed="rId1"/>
          <a:stretch/>
        </p:blipFill>
        <p:spPr>
          <a:xfrm>
            <a:off x="835200" y="74520"/>
            <a:ext cx="4600440" cy="5337360"/>
          </a:xfrm>
          <a:prstGeom prst="rect">
            <a:avLst/>
          </a:prstGeom>
          <a:ln w="0">
            <a:noFill/>
          </a:ln>
        </p:spPr>
      </p:pic>
      <p:sp>
        <p:nvSpPr>
          <p:cNvPr id="42" name="Rettangolo 3"/>
          <p:cNvSpPr/>
          <p:nvPr/>
        </p:nvSpPr>
        <p:spPr>
          <a:xfrm>
            <a:off x="835200" y="5423040"/>
            <a:ext cx="4321080" cy="10983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rPr>
              <a:t>Figure S1</a:t>
            </a:r>
            <a:r>
              <a:rPr b="0" lang="en-US" sz="1100" spc="-1" strike="noStrike">
                <a:solidFill>
                  <a:srgbClr val="000000"/>
                </a:solidFill>
                <a:latin typeface="Calibri"/>
              </a:rPr>
              <a:t>  </a:t>
            </a:r>
            <a:r>
              <a:rPr b="1" lang="en-US" sz="1100" spc="-1" strike="noStrike">
                <a:solidFill>
                  <a:srgbClr val="000000"/>
                </a:solidFill>
                <a:latin typeface="Calibri"/>
              </a:rPr>
              <a:t>Sotalol does not affect freezing during fear reactivation and fear memory testing</a:t>
            </a:r>
            <a:r>
              <a:rPr b="0" lang="en-US" sz="1100" spc="-1" strike="noStrike">
                <a:solidFill>
                  <a:srgbClr val="000000"/>
                </a:solidFill>
                <a:latin typeface="Calibri"/>
              </a:rPr>
              <a:t>. Injecting the selective peripheral β-adrenergic receptor blocker sotalol before the reactivation trial does not reduce freezing during the reactivation trial (left panel) and the long term memory test (right panel) run drug free 48 h later. Data are expressed as mean ± SEM.</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 name="Picture 2" descr="C:\Users\c10218\Downloads\72691_Ammassari-Teule_Figure_6.TIF"/>
          <p:cNvPicPr/>
          <p:nvPr/>
        </p:nvPicPr>
        <p:blipFill>
          <a:blip r:embed="rId1"/>
          <a:stretch/>
        </p:blipFill>
        <p:spPr>
          <a:xfrm>
            <a:off x="826920" y="115920"/>
            <a:ext cx="3024360" cy="5095800"/>
          </a:xfrm>
          <a:prstGeom prst="rect">
            <a:avLst/>
          </a:prstGeom>
          <a:ln w="0">
            <a:noFill/>
          </a:ln>
        </p:spPr>
      </p:pic>
      <p:sp>
        <p:nvSpPr>
          <p:cNvPr id="44" name="Rettangolo 3"/>
          <p:cNvSpPr/>
          <p:nvPr/>
        </p:nvSpPr>
        <p:spPr>
          <a:xfrm>
            <a:off x="900000" y="5157720"/>
            <a:ext cx="3959280" cy="14331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rPr>
              <a:t>Figure S2  Propranolol injected post-reactivation does not reduce fear memory</a:t>
            </a:r>
            <a:r>
              <a:rPr b="0" lang="en-US" sz="1100" spc="-1" strike="noStrike">
                <a:solidFill>
                  <a:srgbClr val="000000"/>
                </a:solidFill>
                <a:latin typeface="Calibri"/>
              </a:rPr>
              <a:t> As already shown in Figure 1, mice injected with propranolol before the reactivation session showed significantly less freezing during the memory test. However, propranolol injected immediately after the reactivation trial does not significantly reduce freezing during the long term memory test run drug free 48 h later (5 mice per group). Data are expressed as mean ± SEM.  * </a:t>
            </a:r>
            <a:r>
              <a:rPr b="0" i="1" lang="en-US" sz="1100" spc="-1" strike="noStrike">
                <a:solidFill>
                  <a:srgbClr val="000000"/>
                </a:solidFill>
                <a:latin typeface="Calibri"/>
              </a:rPr>
              <a:t>p </a:t>
            </a:r>
            <a:r>
              <a:rPr b="0" lang="en-US" sz="1100" spc="-1" strike="noStrike">
                <a:solidFill>
                  <a:srgbClr val="000000"/>
                </a:solidFill>
                <a:latin typeface="Calibri"/>
              </a:rPr>
              <a:t>&lt; 0.025</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5" name="Picture 2" descr="C:\Users\c10218\Downloads\72691_Ammassari-Teule_Figure_7.TIF"/>
          <p:cNvPicPr/>
          <p:nvPr/>
        </p:nvPicPr>
        <p:blipFill>
          <a:blip r:embed="rId1"/>
          <a:stretch/>
        </p:blipFill>
        <p:spPr>
          <a:xfrm>
            <a:off x="684360" y="44280"/>
            <a:ext cx="3377880" cy="5319720"/>
          </a:xfrm>
          <a:prstGeom prst="rect">
            <a:avLst/>
          </a:prstGeom>
          <a:ln w="0">
            <a:noFill/>
          </a:ln>
        </p:spPr>
      </p:pic>
      <p:sp>
        <p:nvSpPr>
          <p:cNvPr id="46" name="Rettangolo 3"/>
          <p:cNvSpPr/>
          <p:nvPr/>
        </p:nvSpPr>
        <p:spPr>
          <a:xfrm>
            <a:off x="755640" y="5376960"/>
            <a:ext cx="3240000" cy="12657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rPr>
              <a:t>Figure S3  Fear memory does not promote spine growth in the ventral hippocampus </a:t>
            </a:r>
            <a:r>
              <a:rPr b="0" lang="en-US" sz="1100" spc="-1" strike="noStrike">
                <a:solidFill>
                  <a:srgbClr val="000000"/>
                </a:solidFill>
                <a:latin typeface="Calibri"/>
              </a:rPr>
              <a:t>Mice subjected to tone fear conditioning and injected with saline before the reactivation trial did not show any increase in spine density in ventral hippocampus CA1 neurons upon the long term memory test. Data are expressed as mean ± SEM. </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7" name="Picture 2" descr="C:\Users\c10218\Downloads\72691_Ammassari-Teule_Figure_8.TIF"/>
          <p:cNvPicPr/>
          <p:nvPr/>
        </p:nvPicPr>
        <p:blipFill>
          <a:blip r:embed="rId1"/>
          <a:stretch/>
        </p:blipFill>
        <p:spPr>
          <a:xfrm>
            <a:off x="900000" y="189000"/>
            <a:ext cx="4023000" cy="4824360"/>
          </a:xfrm>
          <a:prstGeom prst="rect">
            <a:avLst/>
          </a:prstGeom>
          <a:ln w="0">
            <a:noFill/>
          </a:ln>
        </p:spPr>
      </p:pic>
      <p:sp>
        <p:nvSpPr>
          <p:cNvPr id="48" name="Rettangolo 3"/>
          <p:cNvSpPr/>
          <p:nvPr/>
        </p:nvSpPr>
        <p:spPr>
          <a:xfrm>
            <a:off x="900000" y="5013360"/>
            <a:ext cx="4572000" cy="17679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Calibri"/>
              </a:rPr>
              <a:t>Figure S4 Propranolol prevents the increase in p-ERK levels observed upon fear memory testing in the BLA </a:t>
            </a:r>
            <a:r>
              <a:rPr b="0" lang="en-GB" sz="1100" spc="-1" strike="noStrike">
                <a:solidFill>
                  <a:srgbClr val="000000"/>
                </a:solidFill>
                <a:latin typeface="Calibri"/>
              </a:rPr>
              <a:t>Immunohistochemistry staining confirmed western blotting analyses. Mice trained for tone fear conditioning and injected with saline before the reactivation trial showed an increase in BLA p-ERK positive neurons in comparison with saline-injected pseudo-trained mice. Trained mice injected with propranolol before the retention trial showed a consistent reduction in p-ERK positive neurons in the BLA compared to their saline-injected trained counterpart(upper panels). In the CA1 field of the hippocampus, the amount of p-ERK positive neurons did not show variations across experimental conditions.  (lower panels). </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2-10T10:31:45Z</dcterms:created>
  <dc:creator>c10218</dc:creator>
  <dc:description/>
  <dc:language>en-US</dc:language>
  <cp:lastModifiedBy>c10218</cp:lastModifiedBy>
  <dcterms:modified xsi:type="dcterms:W3CDTF">2013-12-10T10:38:58Z</dcterms:modified>
  <cp:revision>1</cp:revision>
  <dc:subject/>
  <dc:title>Presentazione standard di PowerPoint</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DocumentId">
    <vt:lpwstr>Presentation 1.PPT</vt:lpwstr>
  </property>
  <property fmtid="{D5CDD505-2E9C-101B-9397-08002B2CF9AE}" pid="3" name="DocumentType">
    <vt:lpwstr>Presentation</vt:lpwstr>
  </property>
  <property fmtid="{D5CDD505-2E9C-101B-9397-08002B2CF9AE}" pid="4" name="FileFormat">
    <vt:lpwstr>PPT</vt:lpwstr>
  </property>
  <property fmtid="{D5CDD505-2E9C-101B-9397-08002B2CF9AE}" pid="5" name="StageName">
    <vt:lpwstr>Upload</vt:lpwstr>
  </property>
  <property fmtid="{D5CDD505-2E9C-101B-9397-08002B2CF9AE}" pid="6" name="TitleName">
    <vt:lpwstr>Presentation 1.PPT</vt:lpwstr>
  </property>
</Properties>
</file>